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16.pct" ContentType="image/x-pict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embeddings/oleObject1.docx" ContentType="application/vnd.openxmlformats-officedocument.wordprocessingml.documen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39918-89F0-499E-A688-D18F54BF42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83757-66B0-4C1C-AE24-99C85B9CAF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77242-3AA3-412A-83AF-76CAC54C62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88493-0C19-4B73-818A-C381EAF452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F0F417-508B-4F58-8915-7DE6FB0050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BF661A-316E-4C77-BEC4-A6F2093A8B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777533-B936-4729-886C-BDA3C9C22D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0F373-4158-4F53-A5D8-BB745E4504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A810B-23D6-4A54-A3E6-A04C656B5D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A7014B-F7A8-450D-A3E7-B01CE492B4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4E21E-CD3D-4A5A-9966-9F58056725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592488-7498-41B7-B533-DB16C725BE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A4AAF4-FFA5-431B-83DF-65AB09BF7FA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docx"/><Relationship Id="rId2" Type="http://schemas.openxmlformats.org/officeDocument/2006/relationships/image" Target="../media/image16.pct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066680" y="5867280"/>
            <a:ext cx="4284720" cy="25146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367600" y="5191200"/>
            <a:ext cx="957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 Narrow"/>
              </a:rPr>
              <a:t>Stag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378080" y="5238720"/>
            <a:ext cx="412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 Narrow"/>
              </a:rPr>
              <a:t>3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940040" y="5238720"/>
            <a:ext cx="412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 Narrow"/>
              </a:rPr>
              <a:t>3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487960" y="5238720"/>
            <a:ext cx="412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 Narrow"/>
              </a:rPr>
              <a:t>3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092760" y="5238720"/>
            <a:ext cx="412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 Narrow"/>
              </a:rPr>
              <a:t>3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3700800" y="5238720"/>
            <a:ext cx="412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 Narrow"/>
              </a:rPr>
              <a:t>3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283280" y="5238720"/>
            <a:ext cx="412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 Narrow"/>
              </a:rPr>
              <a:t>3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869000" y="5238720"/>
            <a:ext cx="412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 Narrow"/>
              </a:rPr>
              <a:t>3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2"/>
          <a:stretch/>
        </p:blipFill>
        <p:spPr>
          <a:xfrm>
            <a:off x="4745160" y="282600"/>
            <a:ext cx="585720" cy="205740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3"/>
          <a:stretch/>
        </p:blipFill>
        <p:spPr>
          <a:xfrm>
            <a:off x="4232160" y="282600"/>
            <a:ext cx="584280" cy="205884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4"/>
          <a:stretch/>
        </p:blipFill>
        <p:spPr>
          <a:xfrm>
            <a:off x="3676680" y="282600"/>
            <a:ext cx="585720" cy="205884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5"/>
          <a:stretch/>
        </p:blipFill>
        <p:spPr>
          <a:xfrm>
            <a:off x="3135240" y="282600"/>
            <a:ext cx="584280" cy="205884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6"/>
          <a:stretch/>
        </p:blipFill>
        <p:spPr>
          <a:xfrm>
            <a:off x="2589120" y="282600"/>
            <a:ext cx="582840" cy="205884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7"/>
          <a:stretch/>
        </p:blipFill>
        <p:spPr>
          <a:xfrm>
            <a:off x="2027160" y="282600"/>
            <a:ext cx="585720" cy="205884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8"/>
          <a:stretch/>
        </p:blipFill>
        <p:spPr>
          <a:xfrm>
            <a:off x="1428840" y="282600"/>
            <a:ext cx="604800" cy="204156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1297080" y="2301840"/>
            <a:ext cx="736560" cy="98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122640" y="276120"/>
            <a:ext cx="517320" cy="470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990880" y="235080"/>
            <a:ext cx="735120" cy="9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373040" y="228600"/>
            <a:ext cx="1231920" cy="84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422360" y="560520"/>
            <a:ext cx="3919680" cy="185724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352520" y="2122560"/>
            <a:ext cx="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352520" y="677880"/>
            <a:ext cx="73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352520" y="1039680"/>
            <a:ext cx="730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352520" y="1401840"/>
            <a:ext cx="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352520" y="1760400"/>
            <a:ext cx="730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017720" y="188748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017720" y="151776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922320" y="1195560"/>
            <a:ext cx="40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922320" y="870120"/>
            <a:ext cx="40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922320" y="482760"/>
            <a:ext cx="40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398600" y="214632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600200" y="214632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793880" y="214632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807080" y="2260440"/>
            <a:ext cx="529920" cy="84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7440" bIns="374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"/>
          <p:cNvGrpSpPr/>
          <p:nvPr/>
        </p:nvGrpSpPr>
        <p:grpSpPr>
          <a:xfrm>
            <a:off x="1432080" y="3409920"/>
            <a:ext cx="3904920" cy="1760400"/>
            <a:chOff x="1432080" y="3409920"/>
            <a:chExt cx="3904920" cy="1760400"/>
          </a:xfrm>
        </p:grpSpPr>
        <p:pic>
          <p:nvPicPr>
            <p:cNvPr id="77" name="" descr=""/>
            <p:cNvPicPr/>
            <p:nvPr/>
          </p:nvPicPr>
          <p:blipFill>
            <a:blip r:embed="rId9"/>
            <a:stretch/>
          </p:blipFill>
          <p:spPr>
            <a:xfrm>
              <a:off x="4772520" y="3409920"/>
              <a:ext cx="564480" cy="17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" descr=""/>
            <p:cNvPicPr/>
            <p:nvPr/>
          </p:nvPicPr>
          <p:blipFill>
            <a:blip r:embed="rId10"/>
            <a:stretch/>
          </p:blipFill>
          <p:spPr>
            <a:xfrm>
              <a:off x="4215600" y="3409920"/>
              <a:ext cx="564480" cy="17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" descr=""/>
            <p:cNvPicPr/>
            <p:nvPr/>
          </p:nvPicPr>
          <p:blipFill>
            <a:blip r:embed="rId11"/>
            <a:stretch/>
          </p:blipFill>
          <p:spPr>
            <a:xfrm>
              <a:off x="3659040" y="3409920"/>
              <a:ext cx="564480" cy="17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" descr=""/>
            <p:cNvPicPr/>
            <p:nvPr/>
          </p:nvPicPr>
          <p:blipFill>
            <a:blip r:embed="rId12"/>
            <a:stretch/>
          </p:blipFill>
          <p:spPr>
            <a:xfrm>
              <a:off x="3102120" y="3409920"/>
              <a:ext cx="564480" cy="17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" descr=""/>
            <p:cNvPicPr/>
            <p:nvPr/>
          </p:nvPicPr>
          <p:blipFill>
            <a:blip r:embed="rId13"/>
            <a:stretch/>
          </p:blipFill>
          <p:spPr>
            <a:xfrm>
              <a:off x="2545560" y="3409920"/>
              <a:ext cx="564480" cy="17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" descr=""/>
            <p:cNvPicPr/>
            <p:nvPr/>
          </p:nvPicPr>
          <p:blipFill>
            <a:blip r:embed="rId14"/>
            <a:stretch/>
          </p:blipFill>
          <p:spPr>
            <a:xfrm>
              <a:off x="1988640" y="3409920"/>
              <a:ext cx="564480" cy="1760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" descr=""/>
            <p:cNvPicPr/>
            <p:nvPr/>
          </p:nvPicPr>
          <p:blipFill>
            <a:blip r:embed="rId15"/>
            <a:stretch/>
          </p:blipFill>
          <p:spPr>
            <a:xfrm>
              <a:off x="1432080" y="3409920"/>
              <a:ext cx="564480" cy="17604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84" name=""/>
          <p:cNvSpPr/>
          <p:nvPr/>
        </p:nvSpPr>
        <p:spPr>
          <a:xfrm>
            <a:off x="1425600" y="3386160"/>
            <a:ext cx="3917880" cy="1857240"/>
          </a:xfrm>
          <a:prstGeom prst="rect">
            <a:avLst/>
          </a:prstGeom>
          <a:noFill/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353960" y="4616280"/>
            <a:ext cx="73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366920" y="3503520"/>
            <a:ext cx="730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366920" y="3781440"/>
            <a:ext cx="73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366920" y="4059360"/>
            <a:ext cx="73080" cy="28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353960" y="4336920"/>
            <a:ext cx="730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006560" y="438300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006560" y="410364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915840" y="3841920"/>
            <a:ext cx="40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915840" y="3567240"/>
            <a:ext cx="40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915840" y="3284640"/>
            <a:ext cx="406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351080" y="5170320"/>
            <a:ext cx="712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003320" y="494028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003320" y="4667400"/>
            <a:ext cx="29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351080" y="489420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53720" y="81000"/>
            <a:ext cx="430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 Narrow"/>
              </a:rPr>
              <a:t>A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153720" y="5257800"/>
            <a:ext cx="430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 Narrow"/>
              </a:rPr>
              <a:t>B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390680" y="211788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568160" y="2117880"/>
            <a:ext cx="322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753560" y="2117880"/>
            <a:ext cx="308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466360" y="2894040"/>
            <a:ext cx="182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Narrow"/>
              </a:rPr>
              <a:t>PostRMA BoxPLo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510640" y="141120"/>
            <a:ext cx="174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 Narrow"/>
              </a:rPr>
              <a:t>PreRMA BoxPLo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289160" y="5867280"/>
            <a:ext cx="355320" cy="838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193760" y="5842080"/>
            <a:ext cx="0" cy="218448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822240" y="5757840"/>
            <a:ext cx="355680" cy="228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123920" y="5857920"/>
            <a:ext cx="66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117440" y="6373800"/>
            <a:ext cx="73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117440" y="6892920"/>
            <a:ext cx="730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119240" y="7929720"/>
            <a:ext cx="71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119240" y="741204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883800" y="774540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838800" y="723888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825840" y="67374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819720" y="621648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813240" y="566100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 rot="16200000">
            <a:off x="-482400" y="6961320"/>
            <a:ext cx="2412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Narrow"/>
              </a:rPr>
              <a:t>Mean Intensity: Shifted and scal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600200" y="8153280"/>
            <a:ext cx="350532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494000" y="8296200"/>
            <a:ext cx="26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Narrow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592720" y="8298000"/>
            <a:ext cx="261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Narrow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811680" y="8317080"/>
            <a:ext cx="34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Narrow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4954680" y="8298000"/>
            <a:ext cx="342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Narrow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542960" y="8185320"/>
            <a:ext cx="3619440" cy="15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279600" y="7921800"/>
            <a:ext cx="1843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523880" y="8172360"/>
            <a:ext cx="3657600" cy="177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786400" y="8251920"/>
            <a:ext cx="1104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Narrow"/>
              </a:rPr>
              <a:t>Probe numb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908440" y="8273880"/>
            <a:ext cx="83808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706840" y="813924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5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3697560" y="8134200"/>
            <a:ext cx="30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3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 rot="16200000">
            <a:off x="186840" y="4125600"/>
            <a:ext cx="113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Narrow"/>
              </a:rPr>
              <a:t>Mean Intens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rot="16200000">
            <a:off x="188640" y="1296720"/>
            <a:ext cx="113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 Narrow"/>
              </a:rPr>
              <a:t>Mean Intens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1371600" y="2743200"/>
            <a:ext cx="3962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05640" y="2438280"/>
            <a:ext cx="910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 Narrow"/>
              </a:rPr>
              <a:t>Replicat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 flipV="1">
            <a:off x="1249200" y="2477880"/>
            <a:ext cx="322560" cy="114120"/>
          </a:xfrm>
          <a:prstGeom prst="line">
            <a:avLst/>
          </a:prstGeom>
          <a:ln w="2232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7" name=""/>
          <p:cNvGraphicFramePr/>
          <p:nvPr/>
        </p:nvGraphicFramePr>
        <p:xfrm>
          <a:off x="476280" y="3205080"/>
          <a:ext cx="5905440" cy="2733840"/>
        </p:xfrm>
        <a:graphic>
          <a:graphicData uri="http://schemas.openxmlformats.org/presentationml/2006/ole">
            <p:oleObj progId="Word.Document.12" r:id="rId1" spid="">
              <p:embed/>
              <p:pic>
                <p:nvPicPr>
                  <p:cNvPr id="13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76280" y="3205080"/>
                    <a:ext cx="5905440" cy="2733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9" name=""/>
          <p:cNvSpPr/>
          <p:nvPr/>
        </p:nvSpPr>
        <p:spPr>
          <a:xfrm>
            <a:off x="406440" y="1463760"/>
            <a:ext cx="18396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230400" y="2362320"/>
            <a:ext cx="4442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 Narrow"/>
              </a:rPr>
              <a:t>C)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05T22:12:04Z</dcterms:created>
  <dc:creator>Laurent Deluc</dc:creator>
  <dc:description/>
  <dc:language>en-US</dc:language>
  <cp:lastModifiedBy>Grant Cramer</cp:lastModifiedBy>
  <dcterms:modified xsi:type="dcterms:W3CDTF">2007-07-25T18:39:55Z</dcterms:modified>
  <cp:revision>5</cp:revision>
  <dc:subject/>
  <dc:title>PowerPoint Presentation</dc:title>
</cp:coreProperties>
</file>